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182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79895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0309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3093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8536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47778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1108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396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963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04998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7539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4650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843D7-2403-479B-AD41-0B74BE39F262}" type="datetimeFigureOut">
              <a:rPr lang="zh-TW" altLang="en-US" smtClean="0"/>
              <a:t>2024/5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04225-3D70-41CA-B9BA-2DBF1E8151E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56388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0" y="0"/>
            <a:ext cx="24240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1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457199" y="5977145"/>
            <a:ext cx="8991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Principal component analyses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CA) of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data of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,681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COPD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r>
              <a:rPr lang="zh-TW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reen),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,442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D cases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ed) in 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esent study. PC1 represents the first principal component, and PC2 represents the second principal component. They are derived from the PCA of the data.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697" y="464477"/>
            <a:ext cx="8308605" cy="5386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0292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62</Words>
  <Application>Microsoft Office PowerPoint</Application>
  <PresentationFormat>A4 紙張 (210x297 公釐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>WEIGER_B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ei-De Lin</dc:creator>
  <cp:lastModifiedBy>Wei-De Lin</cp:lastModifiedBy>
  <cp:revision>6</cp:revision>
  <dcterms:created xsi:type="dcterms:W3CDTF">2024-03-04T06:30:45Z</dcterms:created>
  <dcterms:modified xsi:type="dcterms:W3CDTF">2024-05-14T08:48:37Z</dcterms:modified>
</cp:coreProperties>
</file>